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ell" initials="D" lastIdx="1" clrIdx="0">
    <p:extLst>
      <p:ext uri="{19B8F6BF-5375-455C-9EA6-DF929625EA0E}">
        <p15:presenceInfo xmlns:p15="http://schemas.microsoft.com/office/powerpoint/2012/main" userId="Dell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41" d="100"/>
          <a:sy n="41" d="100"/>
        </p:scale>
        <p:origin x="25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1357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40424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14713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153331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86272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46771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30702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1398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06533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43069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79031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16836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hyperlink" Target="https://www.ncbi.nlm.nih.gov/entrez/viewer.fcgi?db=nucleotide&amp;id=673536536" TargetMode="External"/><Relationship Id="rId3" Type="http://schemas.openxmlformats.org/officeDocument/2006/relationships/hyperlink" Target="https://www.ncbi.nlm.nih.gov/entrez/viewer.fcgi?db=nucleotide&amp;id=24308465" TargetMode="External"/><Relationship Id="rId7" Type="http://schemas.openxmlformats.org/officeDocument/2006/relationships/hyperlink" Target="https://www.ncbi.nlm.nih.gov/nucleotide/193788619?report=gbwithparts" TargetMode="External"/><Relationship Id="rId12" Type="http://schemas.openxmlformats.org/officeDocument/2006/relationships/hyperlink" Target="https://www.ncbi.nlm.nih.gov/entrez/viewer.fcgi?db=nucleotide&amp;id=225007624" TargetMode="External"/><Relationship Id="rId2" Type="http://schemas.openxmlformats.org/officeDocument/2006/relationships/hyperlink" Target="https://www.ncbi.nlm.nih.gov/entrez/viewer.fcgi?db=nucleotide&amp;id=1046883099" TargetMode="External"/><Relationship Id="rId1" Type="http://schemas.openxmlformats.org/officeDocument/2006/relationships/slideLayout" Target="../slideLayouts/slideLayout6.xml"/><Relationship Id="rId6" Type="http://schemas.openxmlformats.org/officeDocument/2006/relationships/hyperlink" Target="https://www.ncbi.nlm.nih.gov/entrez/viewer.fcgi?db=nucleotide&amp;id=1046886286" TargetMode="External"/><Relationship Id="rId11" Type="http://schemas.openxmlformats.org/officeDocument/2006/relationships/hyperlink" Target="https://www.ncbi.nlm.nih.gov/entrez/viewer.fcgi?db=nucleotide&amp;id=927261963" TargetMode="External"/><Relationship Id="rId5" Type="http://schemas.openxmlformats.org/officeDocument/2006/relationships/hyperlink" Target="https://www.ncbi.nlm.nih.gov/entrez/viewer.fcgi?db=nucleotide&amp;id=254910968" TargetMode="External"/><Relationship Id="rId10" Type="http://schemas.openxmlformats.org/officeDocument/2006/relationships/hyperlink" Target="https://www.ncbi.nlm.nih.gov/nucleotide/162287187?report=gbwithparts" TargetMode="External"/><Relationship Id="rId4" Type="http://schemas.openxmlformats.org/officeDocument/2006/relationships/hyperlink" Target="https://www.ncbi.nlm.nih.gov/entrez/viewer.fcgi?db=nucleotide&amp;id=1450319418" TargetMode="External"/><Relationship Id="rId9" Type="http://schemas.openxmlformats.org/officeDocument/2006/relationships/hyperlink" Target="https://www.ncbi.nlm.nih.gov/entrez/viewer.fcgi?db=nucleotide&amp;id=119637812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D6DC2D4-3CDD-49CF-9117-AE6E49825F3A}"/>
              </a:ext>
            </a:extLst>
          </p:cNvPr>
          <p:cNvSpPr txBox="1"/>
          <p:nvPr/>
        </p:nvSpPr>
        <p:spPr>
          <a:xfrm>
            <a:off x="1231900" y="152400"/>
            <a:ext cx="6816969" cy="3397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IN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1.  List of primers used in the study</a:t>
            </a:r>
            <a:endParaRPr lang="en-IN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41A59C75-5C63-4ACF-B9B0-6CCCD78733A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07722429"/>
              </p:ext>
            </p:extLst>
          </p:nvPr>
        </p:nvGraphicFramePr>
        <p:xfrm>
          <a:off x="544634" y="673100"/>
          <a:ext cx="5335466" cy="10062147"/>
        </p:xfrm>
        <a:graphic>
          <a:graphicData uri="http://schemas.openxmlformats.org/drawingml/2006/table">
            <a:tbl>
              <a:tblPr firstRow="1" firstCol="1" lastRow="1" lastCol="1" bandRow="1" bandCol="1"/>
              <a:tblGrid>
                <a:gridCol w="901700">
                  <a:extLst>
                    <a:ext uri="{9D8B030D-6E8A-4147-A177-3AD203B41FA5}">
                      <a16:colId xmlns:a16="http://schemas.microsoft.com/office/drawing/2014/main" val="3784314128"/>
                    </a:ext>
                  </a:extLst>
                </a:gridCol>
                <a:gridCol w="1714500">
                  <a:extLst>
                    <a:ext uri="{9D8B030D-6E8A-4147-A177-3AD203B41FA5}">
                      <a16:colId xmlns:a16="http://schemas.microsoft.com/office/drawing/2014/main" val="2797545865"/>
                    </a:ext>
                  </a:extLst>
                </a:gridCol>
                <a:gridCol w="2719266">
                  <a:extLst>
                    <a:ext uri="{9D8B030D-6E8A-4147-A177-3AD203B41FA5}">
                      <a16:colId xmlns:a16="http://schemas.microsoft.com/office/drawing/2014/main" val="3684617902"/>
                    </a:ext>
                  </a:extLst>
                </a:gridCol>
              </a:tblGrid>
              <a:tr h="521055"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BABEL Unicode"/>
                          <a:cs typeface="Times New Roman" panose="02020603050405020304" pitchFamily="18" charset="0"/>
                        </a:rPr>
                        <a:t>Genes</a:t>
                      </a:r>
                      <a:endParaRPr lang="en-IN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cession Number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quence (5’ →3’)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026796"/>
                  </a:ext>
                </a:extLst>
              </a:tr>
              <a:tr h="164745">
                <a:tc rowSpan="2"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175"/>
                        </a:spcBef>
                        <a:spcAft>
                          <a:spcPts val="800"/>
                        </a:spcAft>
                      </a:pPr>
                      <a:r>
                        <a:rPr lang="en-IN" sz="1200" i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BABEL Unicode"/>
                          <a:cs typeface="Times New Roman" panose="02020603050405020304" pitchFamily="18" charset="0"/>
                        </a:rPr>
                        <a:t>Actb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75"/>
                        </a:spcBef>
                        <a:spcAft>
                          <a:spcPts val="800"/>
                        </a:spcAft>
                      </a:pPr>
                      <a:r>
                        <a:rPr lang="en-IN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M_031144</a:t>
                      </a:r>
                      <a:endParaRPr lang="en-IN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75"/>
                        </a:spcBef>
                        <a:spcAft>
                          <a:spcPts val="800"/>
                        </a:spcAft>
                      </a:pPr>
                      <a:r>
                        <a:rPr lang="en-IN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CGCGAGTACAACCTTCTTG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1958498"/>
                  </a:ext>
                </a:extLst>
              </a:tr>
              <a:tr h="278690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CATCCATGGCGAACTGGTG</a:t>
                      </a:r>
                      <a:endParaRPr lang="en-IN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802457"/>
                  </a:ext>
                </a:extLst>
              </a:tr>
              <a:tr h="161708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i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BABEL Unicode"/>
                          <a:cs typeface="Times New Roman" panose="02020603050405020304" pitchFamily="18" charset="0"/>
                        </a:rPr>
                        <a:t> Ar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M_013476.4</a:t>
                      </a:r>
                      <a:endParaRPr lang="en-IN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TGGGGACATGCGTTTGGA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0251464"/>
                  </a:ext>
                </a:extLst>
              </a:tr>
              <a:tr h="234161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GTCTTCTGGGGTGGAAAG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0960413"/>
                  </a:ext>
                </a:extLst>
              </a:tr>
              <a:tr h="166914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i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BABEL Unicode"/>
                          <a:cs typeface="Times New Roman" panose="02020603050405020304" pitchFamily="18" charset="0"/>
                        </a:rPr>
                        <a:t> Esr1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XM_017313797.1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TTCTGACAATCGACGCCAG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9533426"/>
                  </a:ext>
                </a:extLst>
              </a:tr>
              <a:tr h="150467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GCTTCAACATTCTCCCTCCTC</a:t>
                      </a:r>
                      <a:endParaRPr lang="en-IN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1575498"/>
                  </a:ext>
                </a:extLst>
              </a:tr>
              <a:tr h="235620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i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BABEL Unicode"/>
                          <a:cs typeface="Times New Roman" panose="02020603050405020304" pitchFamily="18" charset="0"/>
                        </a:rPr>
                        <a:t> Esr2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M_207707.1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CGAAGAGTGCTGTCCCAA</a:t>
                      </a:r>
                      <a:endParaRPr lang="en-IN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8953962"/>
                  </a:ext>
                </a:extLst>
              </a:tr>
              <a:tr h="244573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GGTACATACTGGAGTTGAGG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4154318"/>
                  </a:ext>
                </a:extLst>
              </a:tr>
              <a:tr h="139226">
                <a:tc rowSpan="2"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175"/>
                        </a:spcBef>
                        <a:spcAft>
                          <a:spcPts val="800"/>
                        </a:spcAft>
                      </a:pPr>
                      <a:r>
                        <a:rPr lang="en-IN" sz="1200" i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BABEL Unicode"/>
                          <a:cs typeface="Times New Roman" panose="02020603050405020304" pitchFamily="18" charset="0"/>
                        </a:rPr>
                        <a:t>Pgr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M_008829.2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75"/>
                        </a:spcBef>
                        <a:spcAft>
                          <a:spcPts val="800"/>
                        </a:spcAft>
                      </a:pPr>
                      <a:r>
                        <a:rPr lang="en-IN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GGTCCTTGGAGGTCGTAA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3329370"/>
                  </a:ext>
                </a:extLst>
              </a:tr>
              <a:tr h="249779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ACACCGTCAAGGGTTCTC</a:t>
                      </a:r>
                      <a:endParaRPr lang="en-IN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7651825"/>
                  </a:ext>
                </a:extLst>
              </a:tr>
              <a:tr h="266700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i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mp2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M_00861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TGGTCCGCGTAAAGTATGG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9555794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AACAAGGCTTCATGGGGG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6922149"/>
                  </a:ext>
                </a:extLst>
              </a:tr>
              <a:tr h="262953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i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mp9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M_013599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CCGACTTTTGTGGTCTTC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8499469"/>
                  </a:ext>
                </a:extLst>
              </a:tr>
              <a:tr h="266700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GGTACAAGTATGCCTCTG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0938287"/>
                  </a:ext>
                </a:extLst>
              </a:tr>
              <a:tr h="241300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i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ifr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IN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M_013584</a:t>
                      </a:r>
                      <a:endParaRPr lang="en-IN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GTGGCATTGGCTCCTG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774361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TGTACCCCTCTCTTCAGACC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3221752"/>
                  </a:ext>
                </a:extLst>
              </a:tr>
              <a:tr h="182753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i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tgav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  <a:hlinkClick r:id="rId2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XM_017592332.1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GCAGGGTCAGCTCATTTC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6510346"/>
                  </a:ext>
                </a:extLst>
              </a:tr>
              <a:tr h="115506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CACCATTGAAGTCTCCCACG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8740554"/>
                  </a:ext>
                </a:extLst>
              </a:tr>
              <a:tr h="150112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i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tgb3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  <a:hlinkClick r:id="rId3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NM_153720.1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TTACCAGCAACCTTCGGA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3149965"/>
                  </a:ext>
                </a:extLst>
              </a:tr>
              <a:tr h="273365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TAGCCAAACATGGGCAAGC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281863"/>
                  </a:ext>
                </a:extLst>
              </a:tr>
              <a:tr h="152400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i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tga4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  <a:hlinkClick r:id="rId4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NM_010576.4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ATCTCCTCCACCTACTCACAG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518011"/>
                  </a:ext>
                </a:extLst>
              </a:tr>
              <a:tr h="250253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AACGGCTACATCAACATATCC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9158545"/>
                  </a:ext>
                </a:extLst>
              </a:tr>
              <a:tr h="203200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i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tgb1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  <a:hlinkClick r:id="rId5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NM_010578.2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CAAAGTCTGAGGAATAAAC</a:t>
                      </a:r>
                      <a:endParaRPr lang="en-IN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2386349"/>
                  </a:ext>
                </a:extLst>
              </a:tr>
              <a:tr h="237553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GTTTCAGACTCCTTATTTG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1273428"/>
                  </a:ext>
                </a:extLst>
              </a:tr>
              <a:tr h="144906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i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ox10a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  <a:hlinkClick r:id="rId6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XM_008762948.2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AAGGACTCCCTGGGCAAT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3657444"/>
                  </a:ext>
                </a:extLst>
              </a:tr>
              <a:tr h="153859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CTGGTGCTTCGTGTAAGGG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0536084"/>
                  </a:ext>
                </a:extLst>
              </a:tr>
              <a:tr h="226312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i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ox11a</a:t>
                      </a:r>
                      <a:endParaRPr lang="en-IN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  <a:hlinkClick r:id="rId7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NM_001129878.1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GGTGGCTCCGGTGG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8012677"/>
                  </a:ext>
                </a:extLst>
              </a:tr>
              <a:tr h="260665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TGACTTGACGGTCGGTGAG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2728699"/>
                  </a:ext>
                </a:extLst>
              </a:tr>
              <a:tr h="266700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i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imp1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  <a:hlinkClick r:id="rId8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NM_001294280.2</a:t>
                      </a:r>
                      <a:endParaRPr lang="en-IN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CTTTGCATCTCTGGCATC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8497219"/>
                  </a:ext>
                </a:extLst>
              </a:tr>
              <a:tr h="81153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GCATTTCCCACAGCCTTGAA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5203276"/>
                  </a:ext>
                </a:extLst>
              </a:tr>
              <a:tr h="199453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i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imp3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  <a:hlinkClick r:id="rId9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NM_011595.2</a:t>
                      </a:r>
                      <a:endParaRPr lang="en-IN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CCTCAATTACCGCTACCA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4633850"/>
                  </a:ext>
                </a:extLst>
              </a:tr>
              <a:tr h="221106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GATAGCCAGGGTACCCAAAA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5549109"/>
                  </a:ext>
                </a:extLst>
              </a:tr>
              <a:tr h="153859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i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if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  <a:hlinkClick r:id="rId10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NM_022196.2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TCTTGGCCACAGGGATTGTG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6153451"/>
                  </a:ext>
                </a:extLst>
              </a:tr>
              <a:tr h="226312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GTTCATGAGGTTGCCGTG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2355393"/>
                  </a:ext>
                </a:extLst>
              </a:tr>
              <a:tr h="108265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i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tat3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  <a:hlinkClick r:id="rId11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NM_011486.5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GCCATCCTAAGCACAAAG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9429758"/>
                  </a:ext>
                </a:extLst>
              </a:tr>
              <a:tr h="117218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TCTTGCCACTGATGTCCTT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2795660"/>
                  </a:ext>
                </a:extLst>
              </a:tr>
              <a:tr h="303971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i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p130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IN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  <a:hlinkClick r:id="rId12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NM_010560.3</a:t>
                      </a:r>
                      <a:endParaRPr lang="en-IN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ACACCAAAGTTCGCTCAA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0568755"/>
                  </a:ext>
                </a:extLst>
              </a:tr>
              <a:tr h="241300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algn="ctr">
                        <a:lnSpc>
                          <a:spcPct val="150000"/>
                        </a:lnSpc>
                        <a:spcBef>
                          <a:spcPts val="80"/>
                        </a:spcBef>
                        <a:spcAft>
                          <a:spcPts val="800"/>
                        </a:spcAft>
                      </a:pPr>
                      <a:r>
                        <a:rPr lang="en-IN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CGTCCGAGTACATTTGAT</a:t>
                      </a:r>
                    </a:p>
                  </a:txBody>
                  <a:tcPr marL="3620" marR="3620" marT="3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849089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975468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37</TotalTime>
  <Words>139</Words>
  <Application>Microsoft Office PowerPoint</Application>
  <PresentationFormat>Widescreen</PresentationFormat>
  <Paragraphs>8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Dell</cp:lastModifiedBy>
  <cp:revision>16</cp:revision>
  <dcterms:created xsi:type="dcterms:W3CDTF">2022-04-15T09:53:27Z</dcterms:created>
  <dcterms:modified xsi:type="dcterms:W3CDTF">2022-04-24T13:15:44Z</dcterms:modified>
</cp:coreProperties>
</file>